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4"/>
  </p:notesMasterIdLst>
  <p:sldIdLst>
    <p:sldId id="273" r:id="rId2"/>
    <p:sldId id="301" r:id="rId3"/>
    <p:sldId id="288" r:id="rId4"/>
    <p:sldId id="302" r:id="rId5"/>
    <p:sldId id="291" r:id="rId6"/>
    <p:sldId id="303" r:id="rId7"/>
    <p:sldId id="299" r:id="rId8"/>
    <p:sldId id="304" r:id="rId9"/>
    <p:sldId id="293" r:id="rId10"/>
    <p:sldId id="305" r:id="rId11"/>
    <p:sldId id="300" r:id="rId12"/>
    <p:sldId id="306" r:id="rId1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E3FB68A-1D3A-02EA-96D8-33E2EAB5E1EC}" name="Arun Kumaran Anguraj Vadivel" initials="AKAV" userId="4b2647a43859a28d" providerId="Windows Live"/>
  <p188:author id="{6BB3B2C3-F7DA-A803-9A28-C72069BF1A00}" name="Cynthia Hawkins" initials="CH" userId="S::cynthia.hawkins@sickkids.ca::01122bb1-585f-4d40-b070-e74734f27eb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76" autoAdjust="0"/>
    <p:restoredTop sz="84967" autoAdjust="0"/>
  </p:normalViewPr>
  <p:slideViewPr>
    <p:cSldViewPr snapToGrid="0">
      <p:cViewPr varScale="1">
        <p:scale>
          <a:sx n="44" d="100"/>
          <a:sy n="44" d="100"/>
        </p:scale>
        <p:origin x="2760" y="26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33F60-22E9-4830-B072-255E3D87B3A8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F86428-5AFD-4A06-AC29-B10437A285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202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758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5990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2648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0" dirty="0">
              <a:latin typeface="+mn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1557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38389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F86428-5AFD-4A06-AC29-B10437A28525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72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764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02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484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287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247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85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00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92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630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309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6580E-D785-49A3-A866-9B461DF1FD83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CAB5A-F4F2-46FB-8C2A-AA788462E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029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sv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0.png"/><Relationship Id="rId7" Type="http://schemas.openxmlformats.org/officeDocument/2006/relationships/image" Target="../media/image3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proteinatlas.org/" TargetMode="Externa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E3B80AD-5227-B0D4-A8A5-678384E8C9B8}"/>
              </a:ext>
            </a:extLst>
          </p:cNvPr>
          <p:cNvGrpSpPr/>
          <p:nvPr/>
        </p:nvGrpSpPr>
        <p:grpSpPr>
          <a:xfrm>
            <a:off x="231528" y="546327"/>
            <a:ext cx="6437446" cy="8529835"/>
            <a:chOff x="231528" y="272007"/>
            <a:chExt cx="6437446" cy="8529835"/>
          </a:xfrm>
        </p:grpSpPr>
        <p:pic>
          <p:nvPicPr>
            <p:cNvPr id="7" name="Graphic 6">
              <a:extLst>
                <a:ext uri="{FF2B5EF4-FFF2-40B4-BE49-F238E27FC236}">
                  <a16:creationId xmlns:a16="http://schemas.microsoft.com/office/drawing/2014/main" id="{310DF36A-FC6C-F32A-478C-B214344350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568801" y="3928719"/>
              <a:ext cx="2869548" cy="2296398"/>
            </a:xfrm>
            <a:prstGeom prst="rect">
              <a:avLst/>
            </a:prstGeom>
          </p:spPr>
        </p:pic>
        <p:pic>
          <p:nvPicPr>
            <p:cNvPr id="32" name="Graphic 31">
              <a:extLst>
                <a:ext uri="{FF2B5EF4-FFF2-40B4-BE49-F238E27FC236}">
                  <a16:creationId xmlns:a16="http://schemas.microsoft.com/office/drawing/2014/main" id="{CA953F22-2BD4-408C-1828-0B69E2787AD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3451466" y="3985068"/>
              <a:ext cx="2916676" cy="233411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2C2A34C-E118-E601-D694-7D6320072BC7}"/>
                </a:ext>
              </a:extLst>
            </p:cNvPr>
            <p:cNvSpPr txBox="1"/>
            <p:nvPr/>
          </p:nvSpPr>
          <p:spPr>
            <a:xfrm>
              <a:off x="246768" y="1739527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FEF875D-85BD-4458-8D9A-2B3EE2E4BC4D}"/>
                </a:ext>
              </a:extLst>
            </p:cNvPr>
            <p:cNvSpPr txBox="1"/>
            <p:nvPr/>
          </p:nvSpPr>
          <p:spPr>
            <a:xfrm>
              <a:off x="5025575" y="8540232"/>
              <a:ext cx="16433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1E5DAC3-4BF9-4F77-99E9-1F5CE311F1FD}"/>
                </a:ext>
              </a:extLst>
            </p:cNvPr>
            <p:cNvSpPr txBox="1"/>
            <p:nvPr/>
          </p:nvSpPr>
          <p:spPr>
            <a:xfrm>
              <a:off x="246768" y="272007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84C9114-E475-48A6-AF3C-5C27544D2611}"/>
                </a:ext>
              </a:extLst>
            </p:cNvPr>
            <p:cNvSpPr txBox="1"/>
            <p:nvPr/>
          </p:nvSpPr>
          <p:spPr>
            <a:xfrm>
              <a:off x="231528" y="6056678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2D2EE9C-5E85-3F1D-E277-CD15EA0C1F0C}"/>
                </a:ext>
              </a:extLst>
            </p:cNvPr>
            <p:cNvSpPr txBox="1"/>
            <p:nvPr/>
          </p:nvSpPr>
          <p:spPr>
            <a:xfrm>
              <a:off x="1249932" y="3827572"/>
              <a:ext cx="1643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ome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475E33F-42CB-297F-DC39-7CF931D99329}"/>
                </a:ext>
              </a:extLst>
            </p:cNvPr>
            <p:cNvSpPr txBox="1"/>
            <p:nvPr/>
          </p:nvSpPr>
          <p:spPr>
            <a:xfrm>
              <a:off x="3947258" y="3842814"/>
              <a:ext cx="13020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ome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D45F977-CFA2-7DF0-7DD7-9B94BFC4B699}"/>
                </a:ext>
              </a:extLst>
            </p:cNvPr>
            <p:cNvSpPr txBox="1"/>
            <p:nvPr/>
          </p:nvSpPr>
          <p:spPr>
            <a:xfrm>
              <a:off x="1244447" y="6084151"/>
              <a:ext cx="14462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oproteome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55B6815-8158-9C5A-97F0-B5E3298D1BB5}"/>
                </a:ext>
              </a:extLst>
            </p:cNvPr>
            <p:cNvSpPr txBox="1"/>
            <p:nvPr/>
          </p:nvSpPr>
          <p:spPr>
            <a:xfrm>
              <a:off x="4113995" y="6146056"/>
              <a:ext cx="1463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proteome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825C25D-C6AA-5ACF-A8F0-2ED4EEA30893}"/>
                </a:ext>
              </a:extLst>
            </p:cNvPr>
            <p:cNvSpPr txBox="1"/>
            <p:nvPr/>
          </p:nvSpPr>
          <p:spPr>
            <a:xfrm>
              <a:off x="3352608" y="6169096"/>
              <a:ext cx="3898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7D270BD-82E3-9365-677F-5A7D12BB6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5176" y="6423055"/>
              <a:ext cx="2886166" cy="1649714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5917AAE2-25AA-64BE-94B5-4F28EF35D96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547533" y="6601255"/>
              <a:ext cx="2956085" cy="1408687"/>
            </a:xfrm>
            <a:prstGeom prst="rect">
              <a:avLst/>
            </a:prstGeom>
          </p:spPr>
        </p:pic>
        <p:pic>
          <p:nvPicPr>
            <p:cNvPr id="31" name="Graphic 30">
              <a:extLst>
                <a:ext uri="{FF2B5EF4-FFF2-40B4-BE49-F238E27FC236}">
                  <a16:creationId xmlns:a16="http://schemas.microsoft.com/office/drawing/2014/main" id="{6A929CE3-2B92-B7D2-7759-781E651A7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547207" y="1708887"/>
              <a:ext cx="2764953" cy="2212694"/>
            </a:xfrm>
            <a:prstGeom prst="rect">
              <a:avLst/>
            </a:prstGeom>
          </p:spPr>
        </p:pic>
        <p:pic>
          <p:nvPicPr>
            <p:cNvPr id="35" name="Graphic 34">
              <a:extLst>
                <a:ext uri="{FF2B5EF4-FFF2-40B4-BE49-F238E27FC236}">
                  <a16:creationId xmlns:a16="http://schemas.microsoft.com/office/drawing/2014/main" id="{41880DFB-2912-C9BA-62A7-18CB828F57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2"/>
                </a:ext>
              </a:extLst>
            </a:blip>
            <a:stretch>
              <a:fillRect/>
            </a:stretch>
          </p:blipFill>
          <p:spPr>
            <a:xfrm>
              <a:off x="3315878" y="1660253"/>
              <a:ext cx="2820967" cy="2257521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952BF69-F3BE-4E8D-4D18-47997F5797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77406" y="291371"/>
              <a:ext cx="6133826" cy="155662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195761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9E3DA55-65FE-28A4-A8BD-0B4B21E74B64}"/>
              </a:ext>
            </a:extLst>
          </p:cNvPr>
          <p:cNvSpPr txBox="1"/>
          <p:nvPr/>
        </p:nvSpPr>
        <p:spPr>
          <a:xfrm>
            <a:off x="211015" y="1870227"/>
            <a:ext cx="6506308" cy="18826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Protein synthesis in the knockdown cells.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llurium signal intensity (on </a:t>
            </a:r>
            <a:r>
              <a:rPr lang="en-US" sz="1200" b="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 channel) in the cells detected by CyTOF used for histograms (ungated)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A, SU-DIPGXVII, and SU-DIPG36 cells.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-DIPG36 cells with scrambled ShRNA, METTL13-ShRNA1, or METTL13-ShRNA2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-DIPG36 cells with scrambled ShRNA, METTL21B-ShRNA1, or METTL21B-ShRNA2. </a:t>
            </a:r>
          </a:p>
        </p:txBody>
      </p:sp>
    </p:spTree>
    <p:extLst>
      <p:ext uri="{BB962C8B-B14F-4D97-AF65-F5344CB8AC3E}">
        <p14:creationId xmlns:p14="http://schemas.microsoft.com/office/powerpoint/2010/main" val="17073245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EBFA64AC-3D47-BC8C-4BC9-FFAF52C4EEA7}"/>
              </a:ext>
            </a:extLst>
          </p:cNvPr>
          <p:cNvGrpSpPr/>
          <p:nvPr/>
        </p:nvGrpSpPr>
        <p:grpSpPr>
          <a:xfrm>
            <a:off x="1177900" y="388110"/>
            <a:ext cx="5664860" cy="8718300"/>
            <a:chOff x="1126302" y="239998"/>
            <a:chExt cx="5664860" cy="8718300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104D672-4900-7218-3B37-550BA4023948}"/>
                </a:ext>
              </a:extLst>
            </p:cNvPr>
            <p:cNvSpPr txBox="1"/>
            <p:nvPr/>
          </p:nvSpPr>
          <p:spPr>
            <a:xfrm>
              <a:off x="5009456" y="8681299"/>
              <a:ext cx="17817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6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1C0E955-7765-59B2-21CA-468A1AB545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26302" y="4413419"/>
              <a:ext cx="4052750" cy="204563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ADAB9D9-5F99-2CC2-FFB0-81772BA294D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26302" y="6450421"/>
              <a:ext cx="4052750" cy="2045638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EF73BDB-DBBB-78FA-2788-5E83C9A4C3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26303" y="2282053"/>
              <a:ext cx="4060398" cy="2045638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FE0692F-4B28-F535-7628-5129FE2809B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26302" y="239998"/>
              <a:ext cx="4052754" cy="20456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1022251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A2411E-D99D-973D-AEBC-B75B128DC4B7}"/>
              </a:ext>
            </a:extLst>
          </p:cNvPr>
          <p:cNvSpPr txBox="1"/>
          <p:nvPr/>
        </p:nvSpPr>
        <p:spPr>
          <a:xfrm>
            <a:off x="298937" y="3255221"/>
            <a:ext cx="6242539" cy="7746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Protein composition in METTL13 and METTL21B knockdown DMG cells. Percentage average composition of top 20 differentially proteins in the knockdown cells.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1339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C3F810C-5309-9622-AA1D-81EB7DBA8830}"/>
              </a:ext>
            </a:extLst>
          </p:cNvPr>
          <p:cNvSpPr txBox="1"/>
          <p:nvPr/>
        </p:nvSpPr>
        <p:spPr>
          <a:xfrm>
            <a:off x="281354" y="1316229"/>
            <a:ext cx="6576646" cy="26213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Multiomics profiling of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. </a:t>
            </a: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p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DMG cohort used for multi-omics profiling. OS = median OS, H3 mutation = K27M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plots of transcriptome, total proteome, phosphoproteome, and methylproteome profiles of normal brain and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G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plot of differentially expressed proteins to mRNAs in DMG.</a:t>
            </a: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way enrichment of upregulated proteins that were not differentially expressed at mRNA level (protein:mRNA discordance)  </a:t>
            </a:r>
          </a:p>
        </p:txBody>
      </p:sp>
    </p:spTree>
    <p:extLst>
      <p:ext uri="{BB962C8B-B14F-4D97-AF65-F5344CB8AC3E}">
        <p14:creationId xmlns:p14="http://schemas.microsoft.com/office/powerpoint/2010/main" val="4268596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C0B91F7-47BB-96DB-19E5-3539B21AE991}"/>
              </a:ext>
            </a:extLst>
          </p:cNvPr>
          <p:cNvSpPr txBox="1"/>
          <p:nvPr/>
        </p:nvSpPr>
        <p:spPr>
          <a:xfrm>
            <a:off x="5064738" y="8784702"/>
            <a:ext cx="1656102" cy="2678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A56F158-ADD0-BB1A-6871-9E200B66981D}"/>
              </a:ext>
            </a:extLst>
          </p:cNvPr>
          <p:cNvGrpSpPr/>
          <p:nvPr/>
        </p:nvGrpSpPr>
        <p:grpSpPr>
          <a:xfrm>
            <a:off x="850797" y="409000"/>
            <a:ext cx="4866667" cy="8238542"/>
            <a:chOff x="515517" y="637600"/>
            <a:chExt cx="4866667" cy="8238542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46F399DF-588C-8239-4686-185E4B7B1D32}"/>
                </a:ext>
              </a:extLst>
            </p:cNvPr>
            <p:cNvGrpSpPr/>
            <p:nvPr/>
          </p:nvGrpSpPr>
          <p:grpSpPr>
            <a:xfrm>
              <a:off x="912624" y="4028917"/>
              <a:ext cx="3726744" cy="4831080"/>
              <a:chOff x="912624" y="4028917"/>
              <a:chExt cx="3726744" cy="4831080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229E3ADE-E94B-B4DC-FF31-ED0198F7F7B6}"/>
                  </a:ext>
                </a:extLst>
              </p:cNvPr>
              <p:cNvGrpSpPr/>
              <p:nvPr/>
            </p:nvGrpSpPr>
            <p:grpSpPr>
              <a:xfrm>
                <a:off x="912624" y="4028917"/>
                <a:ext cx="3718538" cy="3901080"/>
                <a:chOff x="463868" y="500929"/>
                <a:chExt cx="5362346" cy="6554972"/>
              </a:xfrm>
            </p:grpSpPr>
            <p:pic>
              <p:nvPicPr>
                <p:cNvPr id="3" name="Picture 2" descr="A picture containing diagram, screenshot, line&#10;&#10;Description automatically generated">
                  <a:extLst>
                    <a:ext uri="{FF2B5EF4-FFF2-40B4-BE49-F238E27FC236}">
                      <a16:creationId xmlns:a16="http://schemas.microsoft.com/office/drawing/2014/main" id="{C65D9339-E8BC-233C-2E20-F299E4BC12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5096" r="15045" b="17183"/>
                <a:stretch/>
              </p:blipFill>
              <p:spPr>
                <a:xfrm>
                  <a:off x="463868" y="2097626"/>
                  <a:ext cx="5349923" cy="1023669"/>
                </a:xfrm>
                <a:prstGeom prst="rect">
                  <a:avLst/>
                </a:prstGeom>
              </p:spPr>
            </p:pic>
            <p:pic>
              <p:nvPicPr>
                <p:cNvPr id="8" name="Picture 7" descr="A picture containing line, screenshot, diagram&#10;&#10;Description automatically generated">
                  <a:extLst>
                    <a:ext uri="{FF2B5EF4-FFF2-40B4-BE49-F238E27FC236}">
                      <a16:creationId xmlns:a16="http://schemas.microsoft.com/office/drawing/2014/main" id="{27BB771E-65E2-013B-4E81-8DB02CFB59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5096" r="13035" b="15952"/>
                <a:stretch/>
              </p:blipFill>
              <p:spPr>
                <a:xfrm>
                  <a:off x="464026" y="6032232"/>
                  <a:ext cx="5362188" cy="1023669"/>
                </a:xfrm>
                <a:prstGeom prst="rect">
                  <a:avLst/>
                </a:prstGeom>
              </p:spPr>
            </p:pic>
            <p:pic>
              <p:nvPicPr>
                <p:cNvPr id="9" name="Picture 8" descr="A picture containing diagram, sketch, line, screenshot&#10;&#10;Description automatically generated">
                  <a:extLst>
                    <a:ext uri="{FF2B5EF4-FFF2-40B4-BE49-F238E27FC236}">
                      <a16:creationId xmlns:a16="http://schemas.microsoft.com/office/drawing/2014/main" id="{7D141F73-E799-EF07-6DFD-B0AA7313BA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5096" r="13234" b="16743"/>
                <a:stretch/>
              </p:blipFill>
              <p:spPr>
                <a:xfrm>
                  <a:off x="464026" y="4763070"/>
                  <a:ext cx="5349922" cy="1009934"/>
                </a:xfrm>
                <a:prstGeom prst="rect">
                  <a:avLst/>
                </a:prstGeom>
              </p:spPr>
            </p:pic>
            <p:pic>
              <p:nvPicPr>
                <p:cNvPr id="10" name="Picture 9" descr="A picture containing diagram, line, screenshot, white&#10;&#10;Description automatically generated">
                  <a:extLst>
                    <a:ext uri="{FF2B5EF4-FFF2-40B4-BE49-F238E27FC236}">
                      <a16:creationId xmlns:a16="http://schemas.microsoft.com/office/drawing/2014/main" id="{850E2C45-7917-6375-D5AD-C6E129651ED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7276" r="13846" b="15840"/>
                <a:stretch/>
              </p:blipFill>
              <p:spPr>
                <a:xfrm>
                  <a:off x="464026" y="3316407"/>
                  <a:ext cx="5349922" cy="1169664"/>
                </a:xfrm>
                <a:prstGeom prst="rect">
                  <a:avLst/>
                </a:prstGeom>
              </p:spPr>
            </p:pic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26F85B53-A4D9-9A6E-0771-F56F5E74C01F}"/>
                    </a:ext>
                  </a:extLst>
                </p:cNvPr>
                <p:cNvSpPr txBox="1"/>
                <p:nvPr/>
              </p:nvSpPr>
              <p:spPr>
                <a:xfrm>
                  <a:off x="3028446" y="3189535"/>
                  <a:ext cx="536268" cy="2423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KT1</a:t>
                  </a:r>
                  <a:endParaRPr lang="en-CA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C84CA89E-81EF-8515-84CE-0AA30D7BF6B2}"/>
                    </a:ext>
                  </a:extLst>
                </p:cNvPr>
                <p:cNvSpPr txBox="1"/>
                <p:nvPr/>
              </p:nvSpPr>
              <p:spPr>
                <a:xfrm>
                  <a:off x="3028444" y="1824760"/>
                  <a:ext cx="528773" cy="2423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K2</a:t>
                  </a:r>
                  <a:endParaRPr lang="en-CA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4FC6F81D-A37A-445F-D638-4F230F9BE885}"/>
                    </a:ext>
                  </a:extLst>
                </p:cNvPr>
                <p:cNvSpPr txBox="1"/>
                <p:nvPr/>
              </p:nvSpPr>
              <p:spPr>
                <a:xfrm>
                  <a:off x="3004560" y="500929"/>
                  <a:ext cx="727390" cy="2423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KACA</a:t>
                  </a:r>
                  <a:endParaRPr lang="en-CA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56D4201-8550-E4CA-22DB-76AC64013CFC}"/>
                    </a:ext>
                  </a:extLst>
                </p:cNvPr>
                <p:cNvSpPr txBox="1"/>
                <p:nvPr/>
              </p:nvSpPr>
              <p:spPr>
                <a:xfrm>
                  <a:off x="3059750" y="4486070"/>
                  <a:ext cx="770486" cy="2423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ETTL13</a:t>
                  </a:r>
                  <a:endParaRPr lang="en-CA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CFCA7D3-58F9-69C6-48BB-9592376DD201}"/>
                    </a:ext>
                  </a:extLst>
                </p:cNvPr>
                <p:cNvSpPr txBox="1"/>
                <p:nvPr/>
              </p:nvSpPr>
              <p:spPr>
                <a:xfrm>
                  <a:off x="3026232" y="5837197"/>
                  <a:ext cx="851058" cy="2423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ETTL21B</a:t>
                  </a:r>
                  <a:endParaRPr lang="en-CA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7" name="Picture 16" descr="A picture containing line, screenshot, diagram, plot&#10;&#10;Description automatically generated">
                  <a:extLst>
                    <a:ext uri="{FF2B5EF4-FFF2-40B4-BE49-F238E27FC236}">
                      <a16:creationId xmlns:a16="http://schemas.microsoft.com/office/drawing/2014/main" id="{C16A6CAF-6A47-3A98-863B-C0580837C6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2836" r="13433" b="16670"/>
                <a:stretch/>
              </p:blipFill>
              <p:spPr>
                <a:xfrm>
                  <a:off x="463868" y="755575"/>
                  <a:ext cx="5362188" cy="1023669"/>
                </a:xfrm>
                <a:prstGeom prst="rect">
                  <a:avLst/>
                </a:prstGeom>
              </p:spPr>
            </p:pic>
          </p:grpSp>
          <p:pic>
            <p:nvPicPr>
              <p:cNvPr id="7" name="Picture 6" descr="A diagram of a tower&#10;&#10;Description automatically generated">
                <a:extLst>
                  <a:ext uri="{FF2B5EF4-FFF2-40B4-BE49-F238E27FC236}">
                    <a16:creationId xmlns:a16="http://schemas.microsoft.com/office/drawing/2014/main" id="{50ECD20F-EFA5-208E-C857-F58E852D6A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259" r="13659"/>
              <a:stretch/>
            </p:blipFill>
            <p:spPr>
              <a:xfrm>
                <a:off x="920939" y="8117775"/>
                <a:ext cx="3718429" cy="742222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F68BD4C-B8FB-3BB0-3C93-23115785934C}"/>
                  </a:ext>
                </a:extLst>
              </p:cNvPr>
              <p:cNvSpPr txBox="1"/>
              <p:nvPr/>
            </p:nvSpPr>
            <p:spPr>
              <a:xfrm>
                <a:off x="2692669" y="7970442"/>
                <a:ext cx="435546" cy="1442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MT5</a:t>
                </a:r>
                <a:endParaRPr lang="en-CA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F17F5A0-9C87-A563-0015-6DC3B95A2DD9}"/>
                </a:ext>
              </a:extLst>
            </p:cNvPr>
            <p:cNvSpPr txBox="1"/>
            <p:nvPr/>
          </p:nvSpPr>
          <p:spPr>
            <a:xfrm>
              <a:off x="515517" y="1236493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B1A1F51-6B52-954C-87DD-142C9D273F95}"/>
                </a:ext>
              </a:extLst>
            </p:cNvPr>
            <p:cNvSpPr txBox="1"/>
            <p:nvPr/>
          </p:nvSpPr>
          <p:spPr>
            <a:xfrm>
              <a:off x="529262" y="662419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299541A-B5AE-5DE6-E6FF-87B1074B31F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57718" y="637600"/>
              <a:ext cx="2324466" cy="1287186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9F5171E2-7552-13D5-CE98-428A2B3FB80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33658" y="702652"/>
              <a:ext cx="1912810" cy="116566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B799B2D-8D45-B4BE-0044-CA1CA2E8FDB9}"/>
                </a:ext>
              </a:extLst>
            </p:cNvPr>
            <p:cNvSpPr txBox="1"/>
            <p:nvPr/>
          </p:nvSpPr>
          <p:spPr>
            <a:xfrm>
              <a:off x="1340980" y="8614978"/>
              <a:ext cx="7681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mune cells</a:t>
              </a:r>
              <a:endParaRPr lang="en-CA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157D912-6B3D-3446-E0CC-C82F7A04C9A9}"/>
                </a:ext>
              </a:extLst>
            </p:cNvPr>
            <p:cNvSpPr txBox="1"/>
            <p:nvPr/>
          </p:nvSpPr>
          <p:spPr>
            <a:xfrm>
              <a:off x="2483081" y="8660698"/>
              <a:ext cx="8547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ignant cells</a:t>
              </a:r>
              <a:endParaRPr lang="en-CA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18C73CA-35EC-C03D-1076-9847A9054AE3}"/>
                </a:ext>
              </a:extLst>
            </p:cNvPr>
            <p:cNvSpPr txBox="1"/>
            <p:nvPr/>
          </p:nvSpPr>
          <p:spPr>
            <a:xfrm>
              <a:off x="3627435" y="8638996"/>
              <a:ext cx="9541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ligodendrocytes</a:t>
              </a:r>
              <a:endParaRPr lang="en-CA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9573489-0408-3204-C171-1FD2EE756011}"/>
                </a:ext>
              </a:extLst>
            </p:cNvPr>
            <p:cNvSpPr txBox="1"/>
            <p:nvPr/>
          </p:nvSpPr>
          <p:spPr>
            <a:xfrm>
              <a:off x="613302" y="3965081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pic>
          <p:nvPicPr>
            <p:cNvPr id="26" name="Picture 25" descr="A black background with a black square&#10;&#10;Description automatically generated with medium confidence">
              <a:extLst>
                <a:ext uri="{FF2B5EF4-FFF2-40B4-BE49-F238E27FC236}">
                  <a16:creationId xmlns:a16="http://schemas.microsoft.com/office/drawing/2014/main" id="{98DA2010-08CC-28F3-D544-95EA82E34E1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947"/>
            <a:stretch/>
          </p:blipFill>
          <p:spPr>
            <a:xfrm>
              <a:off x="785725" y="1264965"/>
              <a:ext cx="3812535" cy="27233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672143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807B63-32A2-997A-A974-535C1EA10612}"/>
              </a:ext>
            </a:extLst>
          </p:cNvPr>
          <p:cNvSpPr txBox="1"/>
          <p:nvPr/>
        </p:nvSpPr>
        <p:spPr>
          <a:xfrm>
            <a:off x="509954" y="1023841"/>
            <a:ext cx="5890846" cy="225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Validation of kinases and methyltransferases’ expression in DMGs.</a:t>
            </a: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validation of PRKACA and PAK2 in knockdown DMG cells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protein kinases identified by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inase enrichment analysis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eir substrates’ phosphorylation in DMG cells (SU-DIPGXVII, SU-DIPG25, and SU-DIPG50) </a:t>
            </a:r>
            <a:r>
              <a:rPr lang="en-US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NAseq validation of kinases and NHMTs candidates in DMG. Public scRNAseq data were retrieve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b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 2018 at https://singlecell.broadinstitute.org/single_cell.   </a:t>
            </a:r>
          </a:p>
        </p:txBody>
      </p:sp>
    </p:spTree>
    <p:extLst>
      <p:ext uri="{BB962C8B-B14F-4D97-AF65-F5344CB8AC3E}">
        <p14:creationId xmlns:p14="http://schemas.microsoft.com/office/powerpoint/2010/main" val="15133086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608F24D-CDC0-0BDA-CBEE-7CA62F800AE9}"/>
              </a:ext>
            </a:extLst>
          </p:cNvPr>
          <p:cNvSpPr txBox="1"/>
          <p:nvPr/>
        </p:nvSpPr>
        <p:spPr>
          <a:xfrm>
            <a:off x="4986886" y="8718301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DC37ABE-DF4D-849B-49B4-51E34C294197}"/>
              </a:ext>
            </a:extLst>
          </p:cNvPr>
          <p:cNvGrpSpPr/>
          <p:nvPr/>
        </p:nvGrpSpPr>
        <p:grpSpPr>
          <a:xfrm>
            <a:off x="434253" y="357619"/>
            <a:ext cx="6043837" cy="8485721"/>
            <a:chOff x="403773" y="205219"/>
            <a:chExt cx="6043837" cy="8485721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29323E87-1291-CDC4-7B6F-F3FBCC6DED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8084" y="7282002"/>
              <a:ext cx="2183447" cy="115336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7" name="Picture 16" descr="A colorful bars on a black background&#10;&#10;Description automatically generated">
              <a:extLst>
                <a:ext uri="{FF2B5EF4-FFF2-40B4-BE49-F238E27FC236}">
                  <a16:creationId xmlns:a16="http://schemas.microsoft.com/office/drawing/2014/main" id="{D39E79F8-852F-58F7-6E62-5663F86022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47143" y="7138686"/>
              <a:ext cx="1020363" cy="1552254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FF878EE-813A-B5C5-D5CF-9E96798F4203}"/>
                </a:ext>
              </a:extLst>
            </p:cNvPr>
            <p:cNvGrpSpPr/>
            <p:nvPr/>
          </p:nvGrpSpPr>
          <p:grpSpPr>
            <a:xfrm>
              <a:off x="403773" y="205219"/>
              <a:ext cx="6043837" cy="7340380"/>
              <a:chOff x="297093" y="205219"/>
              <a:chExt cx="6043837" cy="7340380"/>
            </a:xfrm>
          </p:grpSpPr>
          <p:pic>
            <p:nvPicPr>
              <p:cNvPr id="19" name="Picture 18" descr="A screenshot of a video game&#10;&#10;Description automatically generated">
                <a:extLst>
                  <a:ext uri="{FF2B5EF4-FFF2-40B4-BE49-F238E27FC236}">
                    <a16:creationId xmlns:a16="http://schemas.microsoft.com/office/drawing/2014/main" id="{60C7D38F-567B-D6FA-18ED-E985B5F6BD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710" r="34623"/>
              <a:stretch/>
            </p:blipFill>
            <p:spPr>
              <a:xfrm>
                <a:off x="411810" y="5538230"/>
                <a:ext cx="2529827" cy="1875697"/>
              </a:xfrm>
              <a:prstGeom prst="rect">
                <a:avLst/>
              </a:prstGeom>
            </p:spPr>
          </p:pic>
          <p:pic>
            <p:nvPicPr>
              <p:cNvPr id="26" name="Picture 25" descr="A screenshot of a video game&#10;&#10;Description automatically generated">
                <a:extLst>
                  <a:ext uri="{FF2B5EF4-FFF2-40B4-BE49-F238E27FC236}">
                    <a16:creationId xmlns:a16="http://schemas.microsoft.com/office/drawing/2014/main" id="{80DD1122-A81E-F407-75CE-BFE104A067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387" r="33151"/>
              <a:stretch/>
            </p:blipFill>
            <p:spPr>
              <a:xfrm>
                <a:off x="2804477" y="5636033"/>
                <a:ext cx="2392363" cy="1552254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D51864F4-1A66-29AF-D024-DF9D775CB8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329793" y="2561486"/>
                <a:ext cx="4011137" cy="2997252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645905B-5C7E-5CEE-2DC3-55ECED554034}"/>
                  </a:ext>
                </a:extLst>
              </p:cNvPr>
              <p:cNvSpPr txBox="1"/>
              <p:nvPr/>
            </p:nvSpPr>
            <p:spPr>
              <a:xfrm>
                <a:off x="312333" y="2398921"/>
                <a:ext cx="3898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461B6A8-2B34-3986-87E2-3AC68F303438}"/>
                  </a:ext>
                </a:extLst>
              </p:cNvPr>
              <p:cNvSpPr txBox="1"/>
              <p:nvPr/>
            </p:nvSpPr>
            <p:spPr>
              <a:xfrm>
                <a:off x="2671683" y="2468260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</a:t>
                </a:r>
              </a:p>
            </p:txBody>
          </p:sp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233EBDFC-DFAE-69BD-6C4C-81F490E2A2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75272" y="2555180"/>
                <a:ext cx="2191844" cy="1841149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EC44033-9707-5B66-BB0B-C2AA24C0D308}"/>
                  </a:ext>
                </a:extLst>
              </p:cNvPr>
              <p:cNvSpPr txBox="1"/>
              <p:nvPr/>
            </p:nvSpPr>
            <p:spPr>
              <a:xfrm>
                <a:off x="297093" y="5419101"/>
                <a:ext cx="3898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)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61658FF4-0C20-8A88-5BA4-1129D65BE49F}"/>
                  </a:ext>
                </a:extLst>
              </p:cNvPr>
              <p:cNvSpPr txBox="1"/>
              <p:nvPr/>
            </p:nvSpPr>
            <p:spPr>
              <a:xfrm>
                <a:off x="315902" y="205219"/>
                <a:ext cx="3770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7A6D541-F10C-BAF0-3265-355253D0BE21}"/>
                  </a:ext>
                </a:extLst>
              </p:cNvPr>
              <p:cNvSpPr txBox="1"/>
              <p:nvPr/>
            </p:nvSpPr>
            <p:spPr>
              <a:xfrm>
                <a:off x="1339661" y="5489010"/>
                <a:ext cx="84029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-DIPG25</a:t>
                </a:r>
                <a:endParaRPr lang="en-CA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26D0312-5747-4A80-4A24-80109D68DA5D}"/>
                  </a:ext>
                </a:extLst>
              </p:cNvPr>
              <p:cNvSpPr txBox="1"/>
              <p:nvPr/>
            </p:nvSpPr>
            <p:spPr>
              <a:xfrm>
                <a:off x="3967506" y="5582760"/>
                <a:ext cx="5196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HAs</a:t>
                </a:r>
                <a:endParaRPr lang="en-CA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C680F3A4-2E0E-5FEE-7F08-9D9DE7C94770}"/>
                  </a:ext>
                </a:extLst>
              </p:cNvPr>
              <p:cNvSpPr txBox="1"/>
              <p:nvPr/>
            </p:nvSpPr>
            <p:spPr>
              <a:xfrm>
                <a:off x="390020" y="7176267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)</a:t>
                </a:r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29807FC7-4320-71AB-DEED-5DD38AA6FC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25983" y="4343189"/>
                <a:ext cx="2189089" cy="985925"/>
              </a:xfrm>
              <a:prstGeom prst="rect">
                <a:avLst/>
              </a:prstGeom>
            </p:spPr>
          </p:pic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0528CD7E-B4AB-AEE4-4EC1-8061DD3A685F}"/>
                  </a:ext>
                </a:extLst>
              </p:cNvPr>
              <p:cNvGrpSpPr/>
              <p:nvPr/>
            </p:nvGrpSpPr>
            <p:grpSpPr>
              <a:xfrm>
                <a:off x="361894" y="270319"/>
                <a:ext cx="4945217" cy="2129463"/>
                <a:chOff x="377134" y="270319"/>
                <a:chExt cx="4945217" cy="2129463"/>
              </a:xfrm>
            </p:grpSpPr>
            <p:pic>
              <p:nvPicPr>
                <p:cNvPr id="3" name="Picture 2" descr="A screenshot of a computer screen&#10;&#10;Description automatically generated">
                  <a:extLst>
                    <a:ext uri="{FF2B5EF4-FFF2-40B4-BE49-F238E27FC236}">
                      <a16:creationId xmlns:a16="http://schemas.microsoft.com/office/drawing/2014/main" id="{BE97ACEA-43C7-A437-81C0-E2F84742FF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0408"/>
                <a:stretch/>
              </p:blipFill>
              <p:spPr>
                <a:xfrm>
                  <a:off x="377134" y="270319"/>
                  <a:ext cx="2642038" cy="2128204"/>
                </a:xfrm>
                <a:prstGeom prst="rect">
                  <a:avLst/>
                </a:prstGeom>
              </p:spPr>
            </p:pic>
            <p:pic>
              <p:nvPicPr>
                <p:cNvPr id="11" name="Picture 10" descr="A graph of a graph with purple and pink squar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AE2199A5-82FD-A1F8-8281-6193C6673F8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0448"/>
                <a:stretch/>
              </p:blipFill>
              <p:spPr>
                <a:xfrm>
                  <a:off x="2680313" y="270319"/>
                  <a:ext cx="2642038" cy="2129463"/>
                </a:xfrm>
                <a:prstGeom prst="rect">
                  <a:avLst/>
                </a:prstGeom>
              </p:spPr>
            </p:pic>
          </p:grpSp>
          <p:pic>
            <p:nvPicPr>
              <p:cNvPr id="7" name="Picture 6" descr="A graph of a graph with purple and pink squares&#10;&#10;Description automatically generated with medium confidence">
                <a:extLst>
                  <a:ext uri="{FF2B5EF4-FFF2-40B4-BE49-F238E27FC236}">
                    <a16:creationId xmlns:a16="http://schemas.microsoft.com/office/drawing/2014/main" id="{C62FEF2F-9282-9603-D8BE-228B69366E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255" t="11665" b="56129"/>
              <a:stretch/>
            </p:blipFill>
            <p:spPr>
              <a:xfrm>
                <a:off x="4227353" y="495322"/>
                <a:ext cx="1205894" cy="685800"/>
              </a:xfrm>
              <a:prstGeom prst="rect">
                <a:avLst/>
              </a:prstGeom>
            </p:spPr>
          </p:pic>
          <p:pic>
            <p:nvPicPr>
              <p:cNvPr id="8" name="Picture 7" descr="A screenshot of a video game&#10;&#10;Description automatically generated">
                <a:extLst>
                  <a:ext uri="{FF2B5EF4-FFF2-40B4-BE49-F238E27FC236}">
                    <a16:creationId xmlns:a16="http://schemas.microsoft.com/office/drawing/2014/main" id="{A2C202DA-5417-D360-079B-0F0D26D913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978" t="12387" b="51272"/>
              <a:stretch/>
            </p:blipFill>
            <p:spPr>
              <a:xfrm>
                <a:off x="3361254" y="5705870"/>
                <a:ext cx="1110222" cy="643853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265995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58F9DD-1B07-2E9B-BBB8-1A4DC52661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A02245C-7EAA-8715-9AB7-3CA72BBFE69F}"/>
              </a:ext>
            </a:extLst>
          </p:cNvPr>
          <p:cNvSpPr txBox="1"/>
          <p:nvPr/>
        </p:nvSpPr>
        <p:spPr>
          <a:xfrm>
            <a:off x="509954" y="1023841"/>
            <a:ext cx="5890846" cy="48373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Effect of kinase drugs and METTL knockdown in DMG cells.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 of H-89 (anti-PKA) and A443654 (anti-AKT) drugs on DMG cells growth </a:t>
            </a:r>
            <a:r>
              <a:rPr lang="en-US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validation of upregulation of EEF1A1, METTL13, and METTL21B in DMG tissues compared to normal brain tissues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global lysine protein methylation using pan methyl-lysine antibodies in total protein lysates and EEF1A1-IP samples from normal brain and tumour tissues. 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 of METTL13 knockdown on DMG (SU-DIPG25) and NHA cells growth </a:t>
            </a:r>
            <a:r>
              <a:rPr lang="en-US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ffect on SU-DIPG25 cells was significant (***P&lt;0.0001) but not significant on NHAs on day 4.</a:t>
            </a:r>
          </a:p>
          <a:p>
            <a:pPr marL="228600" marR="0" lvl="0" indent="-22860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R"/>
              <a:tabLst/>
              <a:defRPr/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METTL13 knockdown in SU-DIPG36 cells that were used for </a:t>
            </a:r>
            <a:r>
              <a:rPr lang="en-US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xenograft experiment. METTL13-shRNA2 was used for </a:t>
            </a:r>
            <a:r>
              <a:rPr lang="en-US" sz="1200" b="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. </a:t>
            </a:r>
          </a:p>
        </p:txBody>
      </p:sp>
    </p:spTree>
    <p:extLst>
      <p:ext uri="{BB962C8B-B14F-4D97-AF65-F5344CB8AC3E}">
        <p14:creationId xmlns:p14="http://schemas.microsoft.com/office/powerpoint/2010/main" val="6516003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72D75BD-0AEB-7E66-16B9-E67B9B14CCB5}"/>
              </a:ext>
            </a:extLst>
          </p:cNvPr>
          <p:cNvGrpSpPr/>
          <p:nvPr/>
        </p:nvGrpSpPr>
        <p:grpSpPr>
          <a:xfrm>
            <a:off x="449493" y="379281"/>
            <a:ext cx="6250229" cy="8638009"/>
            <a:chOff x="540933" y="425001"/>
            <a:chExt cx="6250229" cy="863800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CBD8512-58D2-7F5E-32C8-DD19C5862C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66" t="2283" r="1128" b="3023"/>
            <a:stretch/>
          </p:blipFill>
          <p:spPr>
            <a:xfrm>
              <a:off x="1124436" y="3273479"/>
              <a:ext cx="4485378" cy="275566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7EF6A23-1F5B-49A4-FEC1-6BD7EF1496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66" t="1543" r="1666" b="3393"/>
            <a:stretch/>
          </p:blipFill>
          <p:spPr>
            <a:xfrm>
              <a:off x="1124436" y="425001"/>
              <a:ext cx="4469931" cy="277227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9CA5616-924D-0D80-3E72-18479ABC5C97}"/>
                </a:ext>
              </a:extLst>
            </p:cNvPr>
            <p:cNvSpPr txBox="1"/>
            <p:nvPr/>
          </p:nvSpPr>
          <p:spPr>
            <a:xfrm>
              <a:off x="5009456" y="8786011"/>
              <a:ext cx="17817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4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45032DD-3581-9298-D82D-72548D5F9B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9247" t="22342" r="8001" b="5313"/>
            <a:stretch/>
          </p:blipFill>
          <p:spPr>
            <a:xfrm>
              <a:off x="710381" y="6151066"/>
              <a:ext cx="5575612" cy="98529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5C62D8E-6E1A-7AD1-76DD-A6387FAABABC}"/>
                </a:ext>
              </a:extLst>
            </p:cNvPr>
            <p:cNvSpPr txBox="1"/>
            <p:nvPr/>
          </p:nvSpPr>
          <p:spPr>
            <a:xfrm>
              <a:off x="553757" y="453486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5BB2D0D-AC80-26C4-A225-CB06F79E21CB}"/>
                </a:ext>
              </a:extLst>
            </p:cNvPr>
            <p:cNvSpPr txBox="1"/>
            <p:nvPr/>
          </p:nvSpPr>
          <p:spPr>
            <a:xfrm>
              <a:off x="540933" y="5743705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0ACE749-301D-1F09-BC0E-CFBCC88BAF8D}"/>
                </a:ext>
              </a:extLst>
            </p:cNvPr>
            <p:cNvSpPr txBox="1"/>
            <p:nvPr/>
          </p:nvSpPr>
          <p:spPr>
            <a:xfrm>
              <a:off x="689359" y="7103497"/>
              <a:ext cx="8947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TL13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4527460-732A-3393-7E00-663AAE509D45}"/>
                </a:ext>
              </a:extLst>
            </p:cNvPr>
            <p:cNvSpPr txBox="1"/>
            <p:nvPr/>
          </p:nvSpPr>
          <p:spPr>
            <a:xfrm>
              <a:off x="689359" y="8389618"/>
              <a:ext cx="9973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TL21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64343FA-88D0-0D91-716C-913DB17A1E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9729" t="16878" r="8889" b="8475"/>
            <a:stretch/>
          </p:blipFill>
          <p:spPr>
            <a:xfrm>
              <a:off x="710380" y="7450367"/>
              <a:ext cx="5581164" cy="10028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164892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AF81BD2-77CC-6852-7F5F-C256570212D5}"/>
              </a:ext>
            </a:extLst>
          </p:cNvPr>
          <p:cNvSpPr txBox="1"/>
          <p:nvPr/>
        </p:nvSpPr>
        <p:spPr>
          <a:xfrm>
            <a:off x="140678" y="1672147"/>
            <a:ext cx="6717322" cy="1513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Cancer dependency and multi-cancer enrichment of METTL13 and METTL21B. </a:t>
            </a:r>
          </a:p>
          <a:p>
            <a:pPr marL="342900" indent="-342900">
              <a:lnSpc>
                <a:spcPct val="200000"/>
              </a:lnSpc>
              <a:buAutoNum type="alphaLcParenR"/>
            </a:pPr>
            <a:r>
              <a:rPr lang="en-US" sz="12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imation of METTL13 dependency in cancer and normal cell lines by CRISPR knockout perturbation (Cancer Dependency Map Portal, https://depmap.org/portal/). </a:t>
            </a:r>
          </a:p>
          <a:p>
            <a:pPr marL="228600" indent="-228600">
              <a:lnSpc>
                <a:spcPct val="200000"/>
              </a:lnSpc>
              <a:buAutoNum type="alphaLcParenR"/>
            </a:pPr>
            <a:r>
              <a:rPr lang="en-US" sz="12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Immunohistochemistry staining of METTL13 in multiple cancers (</a:t>
            </a:r>
            <a:r>
              <a:rPr lang="en-US" sz="1200" b="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https://www.proteinatlas.org/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)</a:t>
            </a:r>
            <a:endParaRPr lang="en-US" sz="12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18222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7C72F3A-2A1A-2ADF-6A94-9E475825395A}"/>
              </a:ext>
            </a:extLst>
          </p:cNvPr>
          <p:cNvGrpSpPr/>
          <p:nvPr/>
        </p:nvGrpSpPr>
        <p:grpSpPr>
          <a:xfrm>
            <a:off x="406163" y="421843"/>
            <a:ext cx="6398061" cy="8560402"/>
            <a:chOff x="436643" y="574243"/>
            <a:chExt cx="6398061" cy="8560402"/>
          </a:xfrm>
        </p:grpSpPr>
        <p:pic>
          <p:nvPicPr>
            <p:cNvPr id="28" name="Picture 27" descr="A close-up of a chart&#10;&#10;Description automatically generated">
              <a:extLst>
                <a:ext uri="{FF2B5EF4-FFF2-40B4-BE49-F238E27FC236}">
                  <a16:creationId xmlns:a16="http://schemas.microsoft.com/office/drawing/2014/main" id="{177E4ABD-0405-D79C-323F-8602DADAC4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21" t="19851" r="40075" b="58222"/>
            <a:stretch/>
          </p:blipFill>
          <p:spPr>
            <a:xfrm>
              <a:off x="3327132" y="4862288"/>
              <a:ext cx="2934594" cy="2934594"/>
            </a:xfrm>
            <a:prstGeom prst="rect">
              <a:avLst/>
            </a:prstGeom>
          </p:spPr>
        </p:pic>
        <p:pic>
          <p:nvPicPr>
            <p:cNvPr id="24" name="Picture 23" descr="A screenshot of a computer screen&#10;&#10;Description automatically generated">
              <a:extLst>
                <a:ext uri="{FF2B5EF4-FFF2-40B4-BE49-F238E27FC236}">
                  <a16:creationId xmlns:a16="http://schemas.microsoft.com/office/drawing/2014/main" id="{7E9D16C6-0BFA-1D3C-C040-FF6EB6608F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44" t="25037" r="40146" b="43228"/>
            <a:stretch/>
          </p:blipFill>
          <p:spPr>
            <a:xfrm>
              <a:off x="460377" y="4462890"/>
              <a:ext cx="2910969" cy="3299328"/>
            </a:xfrm>
            <a:prstGeom prst="rect">
              <a:avLst/>
            </a:prstGeom>
          </p:spPr>
        </p:pic>
        <p:pic>
          <p:nvPicPr>
            <p:cNvPr id="22" name="Picture 21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986F05D5-63A5-4E20-D027-81BC00E880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62" t="24592" r="47331" b="43704"/>
            <a:stretch/>
          </p:blipFill>
          <p:spPr>
            <a:xfrm>
              <a:off x="707131" y="574243"/>
              <a:ext cx="2652029" cy="363803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6DFF5DE-FDAF-1891-A477-911DC38F5794}"/>
                </a:ext>
              </a:extLst>
            </p:cNvPr>
            <p:cNvSpPr txBox="1"/>
            <p:nvPr/>
          </p:nvSpPr>
          <p:spPr>
            <a:xfrm>
              <a:off x="493035" y="734473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2A1D971-22A0-6218-431B-CC47F9E0BE60}"/>
                </a:ext>
              </a:extLst>
            </p:cNvPr>
            <p:cNvSpPr txBox="1"/>
            <p:nvPr/>
          </p:nvSpPr>
          <p:spPr>
            <a:xfrm>
              <a:off x="436643" y="4565270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7D876AD-1E64-7ED9-9ECB-B9CBEAC22FE8}"/>
                </a:ext>
              </a:extLst>
            </p:cNvPr>
            <p:cNvSpPr txBox="1"/>
            <p:nvPr/>
          </p:nvSpPr>
          <p:spPr>
            <a:xfrm>
              <a:off x="3298422" y="4580510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DE96BB9-4BE5-2B8B-CF59-38EC88EB03B6}"/>
                </a:ext>
              </a:extLst>
            </p:cNvPr>
            <p:cNvSpPr txBox="1"/>
            <p:nvPr/>
          </p:nvSpPr>
          <p:spPr>
            <a:xfrm>
              <a:off x="1464762" y="7701084"/>
              <a:ext cx="1798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TL13- KD vs 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5195F13-CA71-A006-7297-02A3370D9E86}"/>
                </a:ext>
              </a:extLst>
            </p:cNvPr>
            <p:cNvSpPr txBox="1"/>
            <p:nvPr/>
          </p:nvSpPr>
          <p:spPr>
            <a:xfrm>
              <a:off x="4387940" y="7701084"/>
              <a:ext cx="19881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TL21B-KD vs contro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B5C05D9-9840-050C-64D8-7C2764EF606D}"/>
                </a:ext>
              </a:extLst>
            </p:cNvPr>
            <p:cNvSpPr txBox="1"/>
            <p:nvPr/>
          </p:nvSpPr>
          <p:spPr>
            <a:xfrm>
              <a:off x="5052998" y="8857646"/>
              <a:ext cx="17817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BC97028-9803-905D-6F1C-3E9CAA1B477C}"/>
                </a:ext>
              </a:extLst>
            </p:cNvPr>
            <p:cNvSpPr txBox="1"/>
            <p:nvPr/>
          </p:nvSpPr>
          <p:spPr>
            <a:xfrm>
              <a:off x="1863266" y="4043501"/>
              <a:ext cx="17984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HA vs DMG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02406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742</TotalTime>
  <Words>548</Words>
  <Application>Microsoft Office PowerPoint</Application>
  <PresentationFormat>Letter Paper (8.5x11 in)</PresentationFormat>
  <Paragraphs>72</Paragraphs>
  <Slides>12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un Kumaran Anguraj Vadivel</dc:creator>
  <cp:lastModifiedBy>Arun Kumaran Anguraj Vadivel</cp:lastModifiedBy>
  <cp:revision>975</cp:revision>
  <dcterms:created xsi:type="dcterms:W3CDTF">2021-03-15T02:10:15Z</dcterms:created>
  <dcterms:modified xsi:type="dcterms:W3CDTF">2025-01-24T22:00:38Z</dcterms:modified>
</cp:coreProperties>
</file>